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0C1EA40-8B80-48CD-84C8-AF8CBD898643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2AEBD58-DE91-46AE-A949-6226DC5909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3C72FB-23B9-43EE-879F-B6D127127D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C8FD010-A90E-4FBC-8D0D-E2FBA6DE82D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C1641A1-0618-4FAA-8647-7EE81F1B8E49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04C5D58-BAB5-47B4-9ADB-7D166D9916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032C04F-676A-44B6-99B5-8896736684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5183C772-7E29-451B-9513-12952F3972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B8A45E35-BD64-4792-9D00-ECB056C85A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E17597B-C73A-42E7-A69F-C89155DF82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8F0613C-94E9-4675-AADF-0CB1A2E6D5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05A7DA1-2A81-4B92-83DA-59105994C4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B67658D-1C11-4B09-A4E6-CE2A127D93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BC939BAB-4A2B-48CF-96B9-74DC4915A3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43C861D8-559F-4F7E-B819-4858F0D33E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21FE6985-E789-41EA-A8DE-33014A2A8C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B81B2BF-1D2C-472A-AF0A-1A154A11FBF5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160314A-84E0-4F0C-A906-E045AFFA07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F6A8447-8FF7-4162-8756-E222D5BED5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034EFB6-B8A5-48B7-A94A-5B6BFC36A5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E8731EF-4EBD-42B0-840F-EB5352B83B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DAE805C-B071-4880-A1A3-027753EA20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E7E09AF-B703-4B88-B5E3-0E30F34BE2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CD28FDD-E1ED-413F-B605-F580634CE6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2/15/17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30A6ACE3-8151-4746-ACD4-BE6BBBEFCB2C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9000"/>
          </a:bodyPr>
          <a:p>
            <a:pPr marL="3394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 fontScale="96000"/>
          </a:bodyPr>
          <a:p>
            <a:pPr marL="32904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3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2/15/17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sldNum" idx="4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607C79A-327A-471A-A7C2-74257037B6FA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"/>
          <p:cNvGrpSpPr/>
          <p:nvPr/>
        </p:nvGrpSpPr>
        <p:grpSpPr>
          <a:xfrm>
            <a:off x="1042920" y="1474920"/>
            <a:ext cx="6698160" cy="3901320"/>
            <a:chOff x="1042920" y="1474920"/>
            <a:chExt cx="6698160" cy="3901320"/>
          </a:xfrm>
        </p:grpSpPr>
        <p:pic>
          <p:nvPicPr>
            <p:cNvPr id="83" name="" descr=""/>
            <p:cNvPicPr/>
            <p:nvPr/>
          </p:nvPicPr>
          <p:blipFill>
            <a:blip r:embed="rId1"/>
            <a:stretch/>
          </p:blipFill>
          <p:spPr>
            <a:xfrm>
              <a:off x="1833480" y="1549440"/>
              <a:ext cx="5645160" cy="3224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"/>
            <p:cNvSpPr/>
            <p:nvPr/>
          </p:nvSpPr>
          <p:spPr>
            <a:xfrm>
              <a:off x="1756080" y="4659480"/>
              <a:ext cx="29952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614320" y="4659480"/>
              <a:ext cx="41508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543120" y="4659480"/>
              <a:ext cx="41508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458960" y="4659480"/>
              <a:ext cx="41508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6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405040" y="4659480"/>
              <a:ext cx="41508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8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6275160" y="4659480"/>
              <a:ext cx="53100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7210080" y="4659480"/>
              <a:ext cx="53100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2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418760" y="1474920"/>
              <a:ext cx="53100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20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418760" y="2232000"/>
              <a:ext cx="53100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5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418760" y="2987640"/>
              <a:ext cx="53100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643400" y="4500720"/>
              <a:ext cx="29952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530000" y="3745080"/>
              <a:ext cx="415080" cy="41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5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578760" y="4933800"/>
              <a:ext cx="2326320" cy="44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217188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</a:rPr>
                <a:t>Creatinine (uMol/L)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470520" y="3041280"/>
              <a:ext cx="1587240" cy="44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t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</a:rPr>
                <a:t># of Subjects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38160" y="12600"/>
            <a:ext cx="910584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. 2  The distribution of concentrations of creatinine in all 1,762 subject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